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Style moyen 2 - Accentuatio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7736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1416" y="1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CF73A-5546-4D8A-92C0-566F403893B0}" type="datetimeFigureOut">
              <a:rPr lang="en-US" smtClean="0"/>
              <a:t>2/18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A07F4-7935-4BB4-A21E-909A8D659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5751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CF73A-5546-4D8A-92C0-566F403893B0}" type="datetimeFigureOut">
              <a:rPr lang="en-US" smtClean="0"/>
              <a:t>2/18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A07F4-7935-4BB4-A21E-909A8D659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3634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CF73A-5546-4D8A-92C0-566F403893B0}" type="datetimeFigureOut">
              <a:rPr lang="en-US" smtClean="0"/>
              <a:t>2/18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A07F4-7935-4BB4-A21E-909A8D659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5286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CF73A-5546-4D8A-92C0-566F403893B0}" type="datetimeFigureOut">
              <a:rPr lang="en-US" smtClean="0"/>
              <a:t>2/18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A07F4-7935-4BB4-A21E-909A8D659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916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CF73A-5546-4D8A-92C0-566F403893B0}" type="datetimeFigureOut">
              <a:rPr lang="en-US" smtClean="0"/>
              <a:t>2/18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A07F4-7935-4BB4-A21E-909A8D659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9766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CF73A-5546-4D8A-92C0-566F403893B0}" type="datetimeFigureOut">
              <a:rPr lang="en-US" smtClean="0"/>
              <a:t>2/18/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A07F4-7935-4BB4-A21E-909A8D659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2134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CF73A-5546-4D8A-92C0-566F403893B0}" type="datetimeFigureOut">
              <a:rPr lang="en-US" smtClean="0"/>
              <a:t>2/18/19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A07F4-7935-4BB4-A21E-909A8D659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4512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CF73A-5546-4D8A-92C0-566F403893B0}" type="datetimeFigureOut">
              <a:rPr lang="en-US" smtClean="0"/>
              <a:t>2/18/19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A07F4-7935-4BB4-A21E-909A8D659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3748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CF73A-5546-4D8A-92C0-566F403893B0}" type="datetimeFigureOut">
              <a:rPr lang="en-US" smtClean="0"/>
              <a:t>2/18/19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A07F4-7935-4BB4-A21E-909A8D659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834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CF73A-5546-4D8A-92C0-566F403893B0}" type="datetimeFigureOut">
              <a:rPr lang="en-US" smtClean="0"/>
              <a:t>2/18/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A07F4-7935-4BB4-A21E-909A8D659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8363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CF73A-5546-4D8A-92C0-566F403893B0}" type="datetimeFigureOut">
              <a:rPr lang="en-US" smtClean="0"/>
              <a:t>2/18/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A07F4-7935-4BB4-A21E-909A8D659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27785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CCF73A-5546-4D8A-92C0-566F403893B0}" type="datetimeFigureOut">
              <a:rPr lang="en-US" smtClean="0"/>
              <a:t>2/18/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AA07F4-7935-4BB4-A21E-909A8D659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412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3037730"/>
              </p:ext>
            </p:extLst>
          </p:nvPr>
        </p:nvGraphicFramePr>
        <p:xfrm>
          <a:off x="20709" y="639193"/>
          <a:ext cx="6024984" cy="592278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26620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4120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5409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6347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59798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Variables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(n=4405)</a:t>
                      </a:r>
                    </a:p>
                  </a:txBody>
                  <a:tcPr marL="65405" marR="6540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kern="120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urvivors</a:t>
                      </a:r>
                      <a:endParaRPr lang="fr-FR" sz="14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(n=3237)</a:t>
                      </a:r>
                    </a:p>
                  </a:txBody>
                  <a:tcPr marL="65405" marR="6540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Non </a:t>
                      </a:r>
                      <a:r>
                        <a:rPr lang="fr-FR" sz="1400" kern="120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urvivors</a:t>
                      </a:r>
                      <a:endParaRPr lang="fr-FR" sz="14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(n=1168)</a:t>
                      </a:r>
                    </a:p>
                  </a:txBody>
                  <a:tcPr marL="65405" marR="6540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i="1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P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Univ.*</a:t>
                      </a:r>
                    </a:p>
                  </a:txBody>
                  <a:tcPr marL="65405" marR="6540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013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Age: mean  ± SD</a:t>
                      </a:r>
                    </a:p>
                  </a:txBody>
                  <a:tcPr marL="65405" marR="6540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63 ± 16</a:t>
                      </a:r>
                    </a:p>
                  </a:txBody>
                  <a:tcPr marL="65405" marR="6540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68 ± 14</a:t>
                      </a:r>
                    </a:p>
                  </a:txBody>
                  <a:tcPr marL="65405" marR="6540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</a:p>
                  </a:txBody>
                  <a:tcPr marL="65405" marR="6540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6921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ale </a:t>
                      </a:r>
                      <a:r>
                        <a:rPr lang="fr-FR" sz="1300" kern="120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Gender</a:t>
                      </a: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: n (%)</a:t>
                      </a:r>
                    </a:p>
                  </a:txBody>
                  <a:tcPr marL="65405" marR="6540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154 (66)</a:t>
                      </a:r>
                    </a:p>
                  </a:txBody>
                  <a:tcPr marL="65405" marR="6540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714 (61)</a:t>
                      </a:r>
                    </a:p>
                  </a:txBody>
                  <a:tcPr marL="65405" marR="6540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01</a:t>
                      </a:r>
                    </a:p>
                  </a:txBody>
                  <a:tcPr marL="65405" marR="6540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3843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APS2 (</a:t>
                      </a:r>
                      <a:r>
                        <a:rPr lang="fr-FR" sz="1300" kern="120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ean</a:t>
                      </a: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± SD)</a:t>
                      </a:r>
                    </a:p>
                  </a:txBody>
                  <a:tcPr marL="65405" marR="6540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1 ± 18</a:t>
                      </a:r>
                    </a:p>
                  </a:txBody>
                  <a:tcPr marL="65405" marR="6540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64 ± 22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  <a:endParaRPr lang="fr-FR" sz="1300" kern="12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APS2 minus age score (mean ± SD)</a:t>
                      </a:r>
                      <a:endParaRPr lang="fr-FR" sz="1300" kern="12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7  ± 17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0  ± 21</a:t>
                      </a:r>
                      <a:endParaRPr lang="fr-FR" sz="1300" kern="12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9525" marB="0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07396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oexisting condition or risk factors : n (%)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Diabetes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High blood pressure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ancer and hematological malignancies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OPD and chronic respiratory failure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HIV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IV drug abuse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Dialysis dependent chronic kidney disease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Liver Cirrhosis </a:t>
                      </a:r>
                    </a:p>
                  </a:txBody>
                  <a:tcPr marL="65405" marR="6540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10 (13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735 (23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84 (9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20 (10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10 (3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20 (4)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99 (3)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21 (4)</a:t>
                      </a:r>
                    </a:p>
                  </a:txBody>
                  <a:tcPr marL="65405" marR="6540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70 (15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03 (17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18 (10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93 (8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0 (3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5 (1)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4 (3)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85 (7)</a:t>
                      </a:r>
                    </a:p>
                  </a:txBody>
                  <a:tcPr marL="65405" marR="6540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11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007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5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,33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20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94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03</a:t>
                      </a:r>
                    </a:p>
                  </a:txBody>
                  <a:tcPr marL="65405" marR="6540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3506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Intra-</a:t>
                      </a:r>
                      <a:r>
                        <a:rPr lang="fr-FR" sz="1300" kern="120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ardiac</a:t>
                      </a: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fr-FR" sz="1300" kern="120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aterial</a:t>
                      </a: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: n (%)</a:t>
                      </a:r>
                    </a:p>
                  </a:txBody>
                  <a:tcPr marL="65405" marR="6540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56 (14)</a:t>
                      </a:r>
                    </a:p>
                  </a:txBody>
                  <a:tcPr marL="65405" marR="6540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32 (11)</a:t>
                      </a:r>
                    </a:p>
                  </a:txBody>
                  <a:tcPr marL="65405" marR="6540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15</a:t>
                      </a:r>
                    </a:p>
                  </a:txBody>
                  <a:tcPr marL="65405" marR="6540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3506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ongenital</a:t>
                      </a: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fr-FR" sz="1300" kern="120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ardiopathy</a:t>
                      </a: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: n (%)</a:t>
                      </a:r>
                    </a:p>
                  </a:txBody>
                  <a:tcPr marL="65405" marR="6540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7 (1)</a:t>
                      </a:r>
                      <a:endParaRPr lang="fr-FR" sz="1300" kern="12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5 (1)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79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7013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Length of stay in ICU: days (median  (IQR))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 (3-11)</a:t>
                      </a:r>
                      <a:endParaRPr lang="fr-FR" sz="1300" kern="12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7 (3-16)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  <a:endParaRPr lang="fr-FR" sz="1300" kern="12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0101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Length of stay in hospital: days (median  (IQR))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3 (10-44)</a:t>
                      </a:r>
                      <a:endParaRPr lang="fr-FR" sz="1300" kern="12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2 (5-25)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01016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300" u="sng" dirty="0" err="1">
                          <a:effectLst/>
                        </a:rPr>
                        <a:t>Pathogens</a:t>
                      </a:r>
                      <a:r>
                        <a:rPr lang="fr-FR" sz="1300" u="sng" dirty="0">
                          <a:effectLst/>
                        </a:rPr>
                        <a:t>: </a:t>
                      </a:r>
                      <a:r>
                        <a:rPr lang="fr-FR" sz="1300" dirty="0">
                          <a:effectLst/>
                        </a:rPr>
                        <a:t>n (%)</a:t>
                      </a: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la-Latn" sz="1300" i="1" dirty="0">
                          <a:effectLst/>
                        </a:rPr>
                        <a:t>Staphylococcus</a:t>
                      </a:r>
                      <a:r>
                        <a:rPr lang="fr-FR" sz="1300" dirty="0">
                          <a:effectLst/>
                        </a:rPr>
                        <a:t> </a:t>
                      </a:r>
                      <a:r>
                        <a:rPr lang="fr-FR" sz="1300" dirty="0" err="1">
                          <a:effectLst/>
                        </a:rPr>
                        <a:t>sp</a:t>
                      </a:r>
                      <a:r>
                        <a:rPr lang="fr-FR" sz="1300" dirty="0">
                          <a:effectLst/>
                        </a:rPr>
                        <a:t>.</a:t>
                      </a: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300" i="1" dirty="0">
                          <a:effectLst/>
                        </a:rPr>
                        <a:t>Streptococcus </a:t>
                      </a:r>
                      <a:r>
                        <a:rPr lang="fr-FR" sz="1300" dirty="0" err="1">
                          <a:effectLst/>
                        </a:rPr>
                        <a:t>sp</a:t>
                      </a:r>
                      <a:r>
                        <a:rPr lang="fr-FR" sz="1300" dirty="0">
                          <a:effectLst/>
                        </a:rPr>
                        <a:t>.(</a:t>
                      </a:r>
                      <a:r>
                        <a:rPr lang="fr-FR" sz="1300" dirty="0" err="1">
                          <a:effectLst/>
                        </a:rPr>
                        <a:t>except</a:t>
                      </a:r>
                      <a:r>
                        <a:rPr lang="fr-FR" sz="1300" dirty="0">
                          <a:effectLst/>
                        </a:rPr>
                        <a:t> S. </a:t>
                      </a:r>
                      <a:r>
                        <a:rPr lang="fr-FR" sz="1300" dirty="0" err="1">
                          <a:effectLst/>
                        </a:rPr>
                        <a:t>pneumoniae</a:t>
                      </a:r>
                      <a:r>
                        <a:rPr lang="fr-FR" sz="1300" dirty="0">
                          <a:effectLst/>
                        </a:rPr>
                        <a:t>)</a:t>
                      </a: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300" i="1" dirty="0" err="1">
                          <a:effectLst/>
                        </a:rPr>
                        <a:t>Enterococcus</a:t>
                      </a:r>
                      <a:r>
                        <a:rPr lang="fr-FR" sz="1300" dirty="0">
                          <a:effectLst/>
                        </a:rPr>
                        <a:t> </a:t>
                      </a:r>
                      <a:r>
                        <a:rPr lang="fr-FR" sz="1300" dirty="0" err="1">
                          <a:effectLst/>
                        </a:rPr>
                        <a:t>sp</a:t>
                      </a:r>
                      <a:r>
                        <a:rPr lang="fr-FR" sz="1300" dirty="0">
                          <a:effectLst/>
                        </a:rPr>
                        <a:t>. :</a:t>
                      </a: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300" i="1" dirty="0">
                          <a:effectLst/>
                        </a:rPr>
                        <a:t>Streptococcus </a:t>
                      </a:r>
                      <a:r>
                        <a:rPr lang="fr-FR" sz="1300" i="1" dirty="0" err="1">
                          <a:effectLst/>
                        </a:rPr>
                        <a:t>pneumoniae</a:t>
                      </a:r>
                      <a:r>
                        <a:rPr lang="fr-FR" sz="1300" dirty="0">
                          <a:effectLst/>
                        </a:rPr>
                        <a:t>: </a:t>
                      </a: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300" i="1" dirty="0">
                          <a:effectLst/>
                        </a:rPr>
                        <a:t>Pseudomonas aeruginosa</a:t>
                      </a:r>
                      <a:r>
                        <a:rPr lang="en-US" sz="1300" dirty="0">
                          <a:effectLst/>
                        </a:rPr>
                        <a:t>: </a:t>
                      </a:r>
                      <a:endParaRPr lang="fr-FR" sz="1300" dirty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</a:rPr>
                        <a:t>Intra cellular:</a:t>
                      </a:r>
                      <a:endParaRPr lang="fr-FR" sz="1300" dirty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</a:rPr>
                        <a:t>Candida sp.: </a:t>
                      </a:r>
                      <a:endParaRPr lang="fr-FR" sz="1300" dirty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</a:rPr>
                        <a:t>HACEK and </a:t>
                      </a:r>
                      <a:r>
                        <a:rPr lang="en-US" sz="1300" i="1" dirty="0" err="1">
                          <a:effectLst/>
                        </a:rPr>
                        <a:t>Enterobacteriacceae</a:t>
                      </a:r>
                      <a:r>
                        <a:rPr lang="en-US" sz="1300" i="1" dirty="0">
                          <a:effectLst/>
                        </a:rPr>
                        <a:t> </a:t>
                      </a:r>
                      <a:r>
                        <a:rPr lang="en-US" sz="1300" dirty="0">
                          <a:effectLst/>
                        </a:rPr>
                        <a:t>: </a:t>
                      </a:r>
                      <a:endParaRPr lang="fr-FR" sz="13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Cambria" panose="020405030504060302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5405" marR="6540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 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952 (29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607 (19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34 (4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75 (2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71 (2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83 (6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74 (2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36 (7)</a:t>
                      </a:r>
                    </a:p>
                  </a:txBody>
                  <a:tcPr marL="65405" marR="6540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 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52 (39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67 (14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0 (4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1 (2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3 (4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86 (7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8 (4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18 (4)</a:t>
                      </a:r>
                    </a:p>
                  </a:txBody>
                  <a:tcPr marL="65405" marR="6540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 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0007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94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79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23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38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002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19</a:t>
                      </a:r>
                    </a:p>
                  </a:txBody>
                  <a:tcPr marL="65405" marR="6540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graphicFrame>
        <p:nvGraphicFramePr>
          <p:cNvPr id="6" name="Tableau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9719168"/>
              </p:ext>
            </p:extLst>
          </p:nvPr>
        </p:nvGraphicFramePr>
        <p:xfrm>
          <a:off x="6240995" y="639193"/>
          <a:ext cx="5915493" cy="42824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16744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6751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5849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2205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9292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b="1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Interventions and </a:t>
                      </a:r>
                      <a:r>
                        <a:rPr lang="fr-FR" sz="1400" b="1" kern="120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neurological</a:t>
                      </a:r>
                      <a:r>
                        <a:rPr lang="fr-FR" sz="1400" b="1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complications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b="1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(n=4405)</a:t>
                      </a:r>
                    </a:p>
                  </a:txBody>
                  <a:tcPr marL="65405" marR="6540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b="1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urvivors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b="1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(n=3237)</a:t>
                      </a:r>
                    </a:p>
                  </a:txBody>
                  <a:tcPr marL="65405" marR="6540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b="1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Non </a:t>
                      </a:r>
                      <a:r>
                        <a:rPr lang="fr-FR" sz="1400" b="1" kern="120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urvivors</a:t>
                      </a:r>
                      <a:endParaRPr lang="fr-FR" sz="1400" b="1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b="1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(n=1168)</a:t>
                      </a:r>
                    </a:p>
                  </a:txBody>
                  <a:tcPr marL="65405" marR="6540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b="1" i="1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P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b="1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Univ.*</a:t>
                      </a:r>
                    </a:p>
                  </a:txBody>
                  <a:tcPr marL="65405" marR="6540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urgery</a:t>
                      </a: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: n (%)</a:t>
                      </a:r>
                    </a:p>
                  </a:txBody>
                  <a:tcPr marL="65405" marR="6540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355 (36)</a:t>
                      </a:r>
                    </a:p>
                  </a:txBody>
                  <a:tcPr marL="65405" marR="6540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46 (30)</a:t>
                      </a:r>
                    </a:p>
                  </a:txBody>
                  <a:tcPr marL="65405" marR="6540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0004</a:t>
                      </a:r>
                    </a:p>
                  </a:txBody>
                  <a:tcPr marL="65405" marR="6540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486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Acute </a:t>
                      </a:r>
                      <a:r>
                        <a:rPr lang="fr-FR" sz="1300" kern="120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respiratory</a:t>
                      </a: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fr-FR" sz="1300" kern="120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failure</a:t>
                      </a: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: n (%)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echanical</a:t>
                      </a: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ventilation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 Invasive : n (%)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 Non invasive : n (%)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 Invasive ventilation duration: </a:t>
                      </a:r>
                      <a:r>
                        <a:rPr lang="fr-FR" sz="1300" kern="120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days</a:t>
                      </a: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 (</a:t>
                      </a:r>
                      <a:r>
                        <a:rPr lang="fr-FR" sz="1300" kern="120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edian</a:t>
                      </a: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 (IQR))</a:t>
                      </a:r>
                    </a:p>
                  </a:txBody>
                  <a:tcPr marL="65405" marR="6540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829 (57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 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505 (46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04 (9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 (2-11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070 (92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 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016 (87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96 (8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 (2-14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 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 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55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13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9525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Renal replacement therapy: n (%)</a:t>
                      </a:r>
                    </a:p>
                  </a:txBody>
                  <a:tcPr marL="65405" marR="6540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55 (17)</a:t>
                      </a:r>
                    </a:p>
                  </a:txBody>
                  <a:tcPr marL="65405" marR="6540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98 (43)</a:t>
                      </a:r>
                    </a:p>
                  </a:txBody>
                  <a:tcPr marL="65405" marR="6540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  <a:endParaRPr lang="fr-FR" sz="1300" kern="12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Acute circulatory failure: n (%)</a:t>
                      </a:r>
                      <a:endParaRPr lang="fr-FR" sz="1300" kern="12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447 (45)</a:t>
                      </a:r>
                      <a:endParaRPr lang="fr-FR" sz="1300" kern="12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962 (82)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340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Neurological complications: n (%)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 Ischemic or hemorrhagic stroke: n (%)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 Meningitis: n (%)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 Cerebral abscess: n (%)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92 (15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14 (13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98 (3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1 (1)</a:t>
                      </a:r>
                    </a:p>
                  </a:txBody>
                  <a:tcPr marL="65405" marR="6540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88 (25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73 (23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4 (3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8 (1)</a:t>
                      </a:r>
                    </a:p>
                  </a:txBody>
                  <a:tcPr marL="65405" marR="6540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95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0.98</a:t>
                      </a:r>
                    </a:p>
                  </a:txBody>
                  <a:tcPr marL="65405" marR="6540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Length of stay in ICU: days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(median  (IQR))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 (3-11)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7 (3-16)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6243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Length of stay in hospital: days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(median  (IQR))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3 (10-44)</a:t>
                      </a:r>
                      <a:endParaRPr lang="fr-FR" sz="1300" kern="12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2 (5-25)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&lt;0.0001</a:t>
                      </a:r>
                      <a:endParaRPr lang="fr-FR" sz="13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5405" marR="6540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20709" y="268035"/>
            <a:ext cx="3449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6158144" y="268035"/>
            <a:ext cx="3449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0" y="-66363"/>
            <a:ext cx="25301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upplement Table 1</a:t>
            </a:r>
          </a:p>
        </p:txBody>
      </p:sp>
    </p:spTree>
    <p:extLst>
      <p:ext uri="{BB962C8B-B14F-4D97-AF65-F5344CB8AC3E}">
        <p14:creationId xmlns:p14="http://schemas.microsoft.com/office/powerpoint/2010/main" val="75887813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</TotalTime>
  <Words>512</Words>
  <Application>Microsoft Macintosh PowerPoint</Application>
  <PresentationFormat>Grand écran</PresentationFormat>
  <Paragraphs>18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</vt:lpstr>
      <vt:lpstr>Times New Roman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eremie</dc:creator>
  <cp:lastModifiedBy>Microsoft Office User</cp:lastModifiedBy>
  <cp:revision>18</cp:revision>
  <dcterms:created xsi:type="dcterms:W3CDTF">2019-02-02T23:50:55Z</dcterms:created>
  <dcterms:modified xsi:type="dcterms:W3CDTF">2019-02-18T12:29:07Z</dcterms:modified>
</cp:coreProperties>
</file>